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559675" cy="104394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6" d="100"/>
          <a:sy n="76" d="100"/>
        </p:scale>
        <p:origin x="30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29289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96316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6088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4669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6683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9095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25717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8678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06992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76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83963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1063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2A53CCEE-6253-498A-9F7E-3E89C38CA1A4}"/>
              </a:ext>
            </a:extLst>
          </p:cNvPr>
          <p:cNvSpPr/>
          <p:nvPr/>
        </p:nvSpPr>
        <p:spPr>
          <a:xfrm>
            <a:off x="391331" y="5989893"/>
            <a:ext cx="677701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1: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Effect of pH on alpha-glucosidase activity using MUα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lu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as substrate in different feeding conditions and tissues of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.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ongipalpis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emales. Samples were obtained from recently emerged females (0-3 h)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, D, 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, females fed with sucrose 1.2 M for 2 days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, E, H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and females after 2 days of blood feeding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, F, I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. For each feeding condition midgut content fraction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, B, 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, midgut tissue fraction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, E, F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and carcass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, H, I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were analyzed. The points are experimental results and curves were calculated based on constants computed with the softwar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raphi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using equations assuming two ionizable groups. </a:t>
            </a:r>
            <a:endParaRPr lang="pt-BR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E408476-2CC0-4532-BD37-F8DFDF80A30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559675" cy="59898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986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3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ra</dc:creator>
  <cp:lastModifiedBy>Samara Costa Latgé</cp:lastModifiedBy>
  <cp:revision>4</cp:revision>
  <dcterms:created xsi:type="dcterms:W3CDTF">2018-04-05T22:29:35Z</dcterms:created>
  <dcterms:modified xsi:type="dcterms:W3CDTF">2018-10-03T23:30:36Z</dcterms:modified>
</cp:coreProperties>
</file>